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3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34DFF"/>
    <a:srgbClr val="C31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8696"/>
    <p:restoredTop sz="79135"/>
  </p:normalViewPr>
  <p:slideViewPr>
    <p:cSldViewPr snapToGrid="0" snapToObjects="1" showGuides="1">
      <p:cViewPr varScale="1">
        <p:scale>
          <a:sx n="89" d="100"/>
          <a:sy n="89" d="100"/>
        </p:scale>
        <p:origin x="1528" y="1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EFC9D-5C9E-AA47-9441-C16B81334170}" type="datetimeFigureOut">
              <a:rPr lang="en-US" smtClean="0"/>
              <a:t>6/14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76E735-5D82-D741-8505-AF6B9EE58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8595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1: </a:t>
            </a:r>
            <a:r>
              <a:rPr lang="en-CA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referred Reporting Items for Systematic Reviews and Meta-Analyses diagram demonstrating search and inclusion of studies for meta-analysis. diagram and response to treatment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76E735-5D82-D741-8505-AF6B9EE58B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5176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718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83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14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965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519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363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8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01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08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838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481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2A1E76-EC25-E34B-8C8B-F3E280FAB999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899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extBox 170">
            <a:extLst>
              <a:ext uri="{FF2B5EF4-FFF2-40B4-BE49-F238E27FC236}">
                <a16:creationId xmlns:a16="http://schemas.microsoft.com/office/drawing/2014/main" id="{7ECD43B5-3B43-FACB-F988-429DEA448EB4}"/>
              </a:ext>
            </a:extLst>
          </p:cNvPr>
          <p:cNvSpPr txBox="1"/>
          <p:nvPr/>
        </p:nvSpPr>
        <p:spPr>
          <a:xfrm>
            <a:off x="-71944" y="6602725"/>
            <a:ext cx="37176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ankner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4ACB3131-7427-2D4F-8B57-7F73248A5CB1}"/>
              </a:ext>
            </a:extLst>
          </p:cNvPr>
          <p:cNvGrpSpPr/>
          <p:nvPr/>
        </p:nvGrpSpPr>
        <p:grpSpPr>
          <a:xfrm>
            <a:off x="114299" y="189183"/>
            <a:ext cx="8801100" cy="5905644"/>
            <a:chOff x="541471" y="189187"/>
            <a:chExt cx="8136990" cy="3661727"/>
          </a:xfrm>
        </p:grpSpPr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A1209D96-A1CA-60AF-3420-4EDF1B70BF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8091" y="485896"/>
              <a:ext cx="2832011" cy="44461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ecords identified through database searching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N = 105,445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AutoShape 2">
              <a:extLst>
                <a:ext uri="{FF2B5EF4-FFF2-40B4-BE49-F238E27FC236}">
                  <a16:creationId xmlns:a16="http://schemas.microsoft.com/office/drawing/2014/main" id="{A0CA7BB0-3955-0572-67C1-8E243911EDD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1223" y="1591858"/>
              <a:ext cx="857694" cy="377198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Screening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AutoShape 3">
              <a:extLst>
                <a:ext uri="{FF2B5EF4-FFF2-40B4-BE49-F238E27FC236}">
                  <a16:creationId xmlns:a16="http://schemas.microsoft.com/office/drawing/2014/main" id="{EDE8AF46-C57C-C653-8354-6643E60C412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80976" y="3313221"/>
              <a:ext cx="698188" cy="377198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Included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AutoShape 4">
              <a:extLst>
                <a:ext uri="{FF2B5EF4-FFF2-40B4-BE49-F238E27FC236}">
                  <a16:creationId xmlns:a16="http://schemas.microsoft.com/office/drawing/2014/main" id="{DB6CAE9B-92FD-E155-CC72-8B9054F0BCC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80976" y="2455527"/>
              <a:ext cx="698188" cy="377198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Eligibility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AutoShape 8">
              <a:extLst>
                <a:ext uri="{FF2B5EF4-FFF2-40B4-BE49-F238E27FC236}">
                  <a16:creationId xmlns:a16="http://schemas.microsoft.com/office/drawing/2014/main" id="{7091B203-95FA-BDB1-7733-6A34126755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5635" y="932130"/>
              <a:ext cx="0" cy="232729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dirty="0"/>
            </a:p>
          </p:txBody>
        </p:sp>
        <p:sp>
          <p:nvSpPr>
            <p:cNvPr id="48" name="AutoShape 9">
              <a:extLst>
                <a:ext uri="{FF2B5EF4-FFF2-40B4-BE49-F238E27FC236}">
                  <a16:creationId xmlns:a16="http://schemas.microsoft.com/office/drawing/2014/main" id="{E8BFF948-7047-F4F6-72F1-99EABA82DE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04837" y="751756"/>
              <a:ext cx="608705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49" name="AutoShape 5">
              <a:extLst>
                <a:ext uri="{FF2B5EF4-FFF2-40B4-BE49-F238E27FC236}">
                  <a16:creationId xmlns:a16="http://schemas.microsoft.com/office/drawing/2014/main" id="{5C4674DC-7377-2D9B-958C-7F4BD8F197C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85747" y="544911"/>
              <a:ext cx="1088646" cy="377198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Identification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angle 6">
              <a:extLst>
                <a:ext uri="{FF2B5EF4-FFF2-40B4-BE49-F238E27FC236}">
                  <a16:creationId xmlns:a16="http://schemas.microsoft.com/office/drawing/2014/main" id="{04E660F7-5796-628A-34DD-0ADB54EABA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4832" y="485896"/>
              <a:ext cx="2832011" cy="446234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Duplicates removed</a:t>
              </a:r>
              <a:b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</a:b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N = 23,744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7">
              <a:extLst>
                <a:ext uri="{FF2B5EF4-FFF2-40B4-BE49-F238E27FC236}">
                  <a16:creationId xmlns:a16="http://schemas.microsoft.com/office/drawing/2014/main" id="{BC697669-89B6-F3EC-44A5-B2E7A52B1B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7020" y="1161625"/>
              <a:ext cx="3521860" cy="29414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ecords after duplicates removed (N =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81,701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12">
              <a:extLst>
                <a:ext uri="{FF2B5EF4-FFF2-40B4-BE49-F238E27FC236}">
                  <a16:creationId xmlns:a16="http://schemas.microsoft.com/office/drawing/2014/main" id="{30CCA97E-B48A-2831-8235-F04A7A8212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6954" y="1688501"/>
              <a:ext cx="2121991" cy="29091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ecords screened (N =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81,701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ectangle 13">
              <a:extLst>
                <a:ext uri="{FF2B5EF4-FFF2-40B4-BE49-F238E27FC236}">
                  <a16:creationId xmlns:a16="http://schemas.microsoft.com/office/drawing/2014/main" id="{3CF7279E-5644-7695-666D-05E9926859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5957" y="1688501"/>
              <a:ext cx="2178471" cy="29091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ecords excluded (N =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77867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15">
              <a:extLst>
                <a:ext uri="{FF2B5EF4-FFF2-40B4-BE49-F238E27FC236}">
                  <a16:creationId xmlns:a16="http://schemas.microsoft.com/office/drawing/2014/main" id="{95200AD0-9EB2-8837-76D2-25A4C43BAC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8713" y="2153960"/>
              <a:ext cx="2178471" cy="4363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ull-text articles assessed for eligibility (N = 3834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18">
              <a:extLst>
                <a:ext uri="{FF2B5EF4-FFF2-40B4-BE49-F238E27FC236}">
                  <a16:creationId xmlns:a16="http://schemas.microsoft.com/office/drawing/2014/main" id="{27F5A588-6BB9-F544-E7B9-ACFC3534EB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5957" y="2189397"/>
              <a:ext cx="2178471" cy="29091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ull-text articles excluded, with reasons (N =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3812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0AE3D028-3ABA-BE2A-A037-D2ADCFCBA7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8713" y="2769306"/>
              <a:ext cx="2178471" cy="40082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tudies included in qualitative synthesis (N =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20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069AC995-8881-63C5-DDA5-FEBDB3A14B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8713" y="3344676"/>
              <a:ext cx="2178471" cy="445809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tudies included in quantitative synthesis (meta-analysis)</a:t>
              </a:r>
              <a:b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</a:b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N =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20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AutoShape 10">
              <a:extLst>
                <a:ext uri="{FF2B5EF4-FFF2-40B4-BE49-F238E27FC236}">
                  <a16:creationId xmlns:a16="http://schemas.microsoft.com/office/drawing/2014/main" id="{EC7F7DF1-A130-2CD7-092E-FAAD686B80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7949" y="1455771"/>
              <a:ext cx="0" cy="232729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70" name="AutoShape 11">
              <a:extLst>
                <a:ext uri="{FF2B5EF4-FFF2-40B4-BE49-F238E27FC236}">
                  <a16:creationId xmlns:a16="http://schemas.microsoft.com/office/drawing/2014/main" id="{C733D799-B5E6-1A7C-3FC8-FE9EE53F30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7949" y="1979413"/>
              <a:ext cx="0" cy="174547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71" name="AutoShape 16">
              <a:extLst>
                <a:ext uri="{FF2B5EF4-FFF2-40B4-BE49-F238E27FC236}">
                  <a16:creationId xmlns:a16="http://schemas.microsoft.com/office/drawing/2014/main" id="{EB5C4639-D4D8-1EA1-0DE4-73404D98F4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7949" y="2589335"/>
              <a:ext cx="0" cy="174547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72" name="AutoShape 21">
              <a:extLst>
                <a:ext uri="{FF2B5EF4-FFF2-40B4-BE49-F238E27FC236}">
                  <a16:creationId xmlns:a16="http://schemas.microsoft.com/office/drawing/2014/main" id="{0C4B5D00-014A-A941-F7A4-4459E45AA9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7949" y="3170129"/>
              <a:ext cx="0" cy="174547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78" name="AutoShape 14">
              <a:extLst>
                <a:ext uri="{FF2B5EF4-FFF2-40B4-BE49-F238E27FC236}">
                  <a16:creationId xmlns:a16="http://schemas.microsoft.com/office/drawing/2014/main" id="{E96F64DB-B298-51DD-9D35-C77DD4D3F6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68945" y="1833957"/>
              <a:ext cx="827012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79" name="AutoShape 17">
              <a:extLst>
                <a:ext uri="{FF2B5EF4-FFF2-40B4-BE49-F238E27FC236}">
                  <a16:creationId xmlns:a16="http://schemas.microsoft.com/office/drawing/2014/main" id="{3661B955-A46D-53B9-DE9D-A5A164E999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97184" y="2328507"/>
              <a:ext cx="798773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80" name="Rectangle 22">
              <a:extLst>
                <a:ext uri="{FF2B5EF4-FFF2-40B4-BE49-F238E27FC236}">
                  <a16:creationId xmlns:a16="http://schemas.microsoft.com/office/drawing/2014/main" id="{B0468347-8CAB-9072-A2E4-C338D9EE57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9990" y="3352518"/>
              <a:ext cx="2178471" cy="43796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atients included in quantitative synthesis (meta-analysis)</a:t>
              </a:r>
              <a:b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</a:b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N = 46)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AutoShape 23">
              <a:extLst>
                <a:ext uri="{FF2B5EF4-FFF2-40B4-BE49-F238E27FC236}">
                  <a16:creationId xmlns:a16="http://schemas.microsoft.com/office/drawing/2014/main" id="{123FA3E6-AFC3-BE6A-F6BB-BBD35C8193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99201" y="3583628"/>
              <a:ext cx="798773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</p:grpSp>
    </p:spTree>
    <p:extLst>
      <p:ext uri="{BB962C8B-B14F-4D97-AF65-F5344CB8AC3E}">
        <p14:creationId xmlns:p14="http://schemas.microsoft.com/office/powerpoint/2010/main" val="531303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738</TotalTime>
  <Words>140</Words>
  <Application>Microsoft Macintosh PowerPoint</Application>
  <PresentationFormat>Letter Paper (8.5x11 in)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Siegel</dc:creator>
  <cp:lastModifiedBy>Matthew Dankner</cp:lastModifiedBy>
  <cp:revision>213</cp:revision>
  <dcterms:created xsi:type="dcterms:W3CDTF">2020-04-05T17:20:22Z</dcterms:created>
  <dcterms:modified xsi:type="dcterms:W3CDTF">2023-06-14T11:34:50Z</dcterms:modified>
</cp:coreProperties>
</file>